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60" r:id="rId5"/>
    <p:sldId id="259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58B838-9C67-43F0-8071-BD02696172CF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D7AE86-A245-4EF5-9A08-8FA0658D9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950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84506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3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0482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6B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3142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6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3022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6E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07416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7A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99858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7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13858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7F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D7AE86-A245-4EF5-9A08-8FA0658D9A63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8240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E5DBDD-8ABC-11A2-6D77-5272BDAE88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6842E6A-CFCB-520D-C423-ACB1DF2913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1AA434-325C-C2F6-24D2-768030D60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AF3C0F-4057-46FF-E510-E6ACC8919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5045C7-F443-789E-93DE-117FF24F5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670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56BB75-B030-A774-35FE-E3077ACDA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A860580-3CB5-089C-00E4-70C78865F4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EAB659-8AD3-5A95-F6DD-D62A94C12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186652-997E-F980-3184-F55EF3014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02B96A-E597-7121-9765-D70C08EBC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095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6DA0DDB-528D-1ACC-E4A9-339971AB52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7CCFAE-0F69-2ED8-645B-33DC2DC905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73ADB0-C2D5-9291-4F32-D1EC7D3A9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F22CA2-15D6-8E2F-9D5D-E2C6DBE0B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156C8B-C249-99CE-D261-3007FE170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873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22E2C1-2D87-1390-751E-D4E76AA33A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430503-8110-E269-4BA7-FCBF949BD0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F873A8-6AD9-CD75-3B08-A3624668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71E762-DF86-4B69-0293-E82029540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858D04-BE45-D25E-FB61-D83A6ADAA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9352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17BD9B-C076-E6AE-1EB0-8748F84487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FD3E7B-D982-0803-0665-25B6C86B47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822A8C-8DED-E4FC-9B6B-62A88151C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F20765-B98E-075F-6282-35DB10140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98A467-B3D5-FE23-6F51-FBDC025E2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712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CAD300-D85D-BE14-DA23-D8911F8B95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A2B886-9CAE-6E0B-A53A-7641DC7369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29002D-325E-4566-C879-C193DB6F02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D5F350-1C7A-2714-C25A-51C20DEC8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EB5D0D6-1D00-9E33-BF88-891C48EF8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D87FEF-4307-EA9A-1CAE-3FE88629C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2182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B8BE19-4ABE-A430-7F52-459908990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A9BA6E-4A68-297B-614B-D7FD87AB73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6DEE4F3-BBE8-72B5-0939-6D783FFFFD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3DC90C3-B15D-4F9C-2AD7-9C47C5826D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1ED49A9-D304-484A-6CE6-543D66720D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F9164D7-BC4E-C1FD-D23F-7927DC2E5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0595B22-70D9-9856-4C75-B7C38C9B6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9D729D9-DAB7-C314-E876-FD0257633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9650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23DB4-9019-652D-1BC6-EBD2D1E1F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A11D47E-5490-0C50-28CB-7DA24FD53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41CA7BF-8F3C-E882-854E-92FEF8CF1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7B63AB6-5266-4813-2202-44F9A33B2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188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8D601DF-AFDB-5B05-E82B-19D977919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1FE7001-676B-9591-DBB5-A8FB6B9B4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4B365A0-BF09-0466-2F3F-471C6EE02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4770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1012F3-46E7-8E29-E97C-AA3DDD3D0B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8B1BBB-C771-223E-5604-E617FB9BDA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E0D5681-D58F-A9B3-4D87-E3218EBBDE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F0CAFE-AA45-1DBF-0930-842B9EDE7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8410D4-17E7-6038-8839-3B9DBE674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F669C40-9DC0-CB1B-2002-634342276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68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4976B3-6884-6C96-A079-D1BCF53CA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0595CC8-9B1B-AB3C-7DB6-421FCBFAD3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34367C0-581F-0AAE-121C-DFB589B74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C53169-F0CC-EAA1-26B5-14037197F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A8169B-0C41-813B-AC75-FF9200B5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AC9CF4-69C6-660B-9420-67C32FD75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218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8BA2EC0-F456-E823-7F55-D0342E312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C68A3D2-89EE-962A-1B22-80146D3551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9E5AD9-966E-BBEC-D82D-17C96A4C67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57C3-6826-4DFA-BADD-418999CF800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3F2E77-E975-5C43-D810-E67CFF4166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EDA083-938C-8CA5-6A6B-3644BDF43A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B3B34-5A8A-4B99-B05C-E67CCD70E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14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5" Type="http://schemas.openxmlformats.org/officeDocument/2006/relationships/image" Target="../media/image2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5" Type="http://schemas.openxmlformats.org/officeDocument/2006/relationships/image" Target="../media/image4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Relationship Id="rId14" Type="http://schemas.openxmlformats.org/officeDocument/2006/relationships/image" Target="../media/image4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13" Type="http://schemas.openxmlformats.org/officeDocument/2006/relationships/image" Target="../media/image58.png"/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12" Type="http://schemas.openxmlformats.org/officeDocument/2006/relationships/image" Target="../media/image5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11" Type="http://schemas.openxmlformats.org/officeDocument/2006/relationships/image" Target="../media/image56.png"/><Relationship Id="rId5" Type="http://schemas.openxmlformats.org/officeDocument/2006/relationships/image" Target="../media/image50.png"/><Relationship Id="rId10" Type="http://schemas.openxmlformats.org/officeDocument/2006/relationships/image" Target="../media/image55.png"/><Relationship Id="rId4" Type="http://schemas.openxmlformats.org/officeDocument/2006/relationships/image" Target="../media/image49.png"/><Relationship Id="rId9" Type="http://schemas.openxmlformats.org/officeDocument/2006/relationships/image" Target="../media/image5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13" Type="http://schemas.openxmlformats.org/officeDocument/2006/relationships/image" Target="../media/image69.png"/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12" Type="http://schemas.openxmlformats.org/officeDocument/2006/relationships/image" Target="../media/image6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png"/><Relationship Id="rId11" Type="http://schemas.openxmlformats.org/officeDocument/2006/relationships/image" Target="../media/image67.png"/><Relationship Id="rId5" Type="http://schemas.openxmlformats.org/officeDocument/2006/relationships/image" Target="../media/image61.png"/><Relationship Id="rId10" Type="http://schemas.openxmlformats.org/officeDocument/2006/relationships/image" Target="../media/image66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png"/><Relationship Id="rId13" Type="http://schemas.openxmlformats.org/officeDocument/2006/relationships/image" Target="../media/image80.png"/><Relationship Id="rId3" Type="http://schemas.openxmlformats.org/officeDocument/2006/relationships/image" Target="../media/image70.png"/><Relationship Id="rId7" Type="http://schemas.openxmlformats.org/officeDocument/2006/relationships/image" Target="../media/image74.png"/><Relationship Id="rId12" Type="http://schemas.openxmlformats.org/officeDocument/2006/relationships/image" Target="../media/image7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11" Type="http://schemas.openxmlformats.org/officeDocument/2006/relationships/image" Target="../media/image78.png"/><Relationship Id="rId5" Type="http://schemas.openxmlformats.org/officeDocument/2006/relationships/image" Target="../media/image72.png"/><Relationship Id="rId15" Type="http://schemas.openxmlformats.org/officeDocument/2006/relationships/image" Target="../media/image82.png"/><Relationship Id="rId10" Type="http://schemas.openxmlformats.org/officeDocument/2006/relationships/image" Target="../media/image77.png"/><Relationship Id="rId4" Type="http://schemas.openxmlformats.org/officeDocument/2006/relationships/image" Target="../media/image71.png"/><Relationship Id="rId9" Type="http://schemas.openxmlformats.org/officeDocument/2006/relationships/image" Target="../media/image76.png"/><Relationship Id="rId14" Type="http://schemas.openxmlformats.org/officeDocument/2006/relationships/image" Target="../media/image8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617F1EC-B77D-A55E-F894-0999B61A13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9300" y="4990863"/>
            <a:ext cx="2707001" cy="82732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241F4C5-5D29-2861-EEF8-5649FC8A53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1259" y="5029049"/>
            <a:ext cx="2805296" cy="92122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7D7AEF9-43B9-BEC2-78A3-75B6FB05DA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5162" y="3117711"/>
            <a:ext cx="2561757" cy="142958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B49CEAC-C38A-C596-F60C-C94EB45E5F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28698" y="3117711"/>
            <a:ext cx="2503752" cy="138715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2586A95-E212-86E4-2272-33CB317F32DD}"/>
              </a:ext>
            </a:extLst>
          </p:cNvPr>
          <p:cNvSpPr txBox="1"/>
          <p:nvPr/>
        </p:nvSpPr>
        <p:spPr>
          <a:xfrm>
            <a:off x="938644" y="3576220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25kd</a:t>
            </a:r>
            <a:endParaRPr lang="zh-CN" altLang="en-US" sz="14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A9EE4F5-77DB-E47C-05BB-29BBA1E1B2A3}"/>
              </a:ext>
            </a:extLst>
          </p:cNvPr>
          <p:cNvSpPr txBox="1"/>
          <p:nvPr/>
        </p:nvSpPr>
        <p:spPr>
          <a:xfrm>
            <a:off x="983735" y="425748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9F058A2-B14A-F289-D76E-CE6525228AEF}"/>
              </a:ext>
            </a:extLst>
          </p:cNvPr>
          <p:cNvSpPr txBox="1"/>
          <p:nvPr/>
        </p:nvSpPr>
        <p:spPr>
          <a:xfrm>
            <a:off x="941653" y="5489659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FFEF212-7939-2F76-74B1-B03F4451A361}"/>
              </a:ext>
            </a:extLst>
          </p:cNvPr>
          <p:cNvSpPr txBox="1"/>
          <p:nvPr/>
        </p:nvSpPr>
        <p:spPr>
          <a:xfrm>
            <a:off x="919109" y="530425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3F64F6F-1C2C-5C66-5AA7-6705AC9DACF0}"/>
              </a:ext>
            </a:extLst>
          </p:cNvPr>
          <p:cNvSpPr txBox="1"/>
          <p:nvPr/>
        </p:nvSpPr>
        <p:spPr>
          <a:xfrm>
            <a:off x="922520" y="5136506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EEEF676E-F761-B6A6-2099-5E8A8FACB7AA}"/>
              </a:ext>
            </a:extLst>
          </p:cNvPr>
          <p:cNvCxnSpPr/>
          <p:nvPr/>
        </p:nvCxnSpPr>
        <p:spPr>
          <a:xfrm>
            <a:off x="1503216" y="373010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CBB6AF9F-9C06-620B-A215-7CF8696B55BB}"/>
              </a:ext>
            </a:extLst>
          </p:cNvPr>
          <p:cNvCxnSpPr/>
          <p:nvPr/>
        </p:nvCxnSpPr>
        <p:spPr>
          <a:xfrm>
            <a:off x="1524061" y="441137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D9D832A1-7DE4-B018-18E3-305FC6E6E98A}"/>
              </a:ext>
            </a:extLst>
          </p:cNvPr>
          <p:cNvCxnSpPr/>
          <p:nvPr/>
        </p:nvCxnSpPr>
        <p:spPr>
          <a:xfrm>
            <a:off x="1524061" y="529039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5264624B-18B6-B25E-8F45-E949C302B726}"/>
              </a:ext>
            </a:extLst>
          </p:cNvPr>
          <p:cNvCxnSpPr/>
          <p:nvPr/>
        </p:nvCxnSpPr>
        <p:spPr>
          <a:xfrm>
            <a:off x="1520650" y="545813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BAA56543-DCB8-6AC0-2317-CE357ECAD5F8}"/>
              </a:ext>
            </a:extLst>
          </p:cNvPr>
          <p:cNvCxnSpPr/>
          <p:nvPr/>
        </p:nvCxnSpPr>
        <p:spPr>
          <a:xfrm>
            <a:off x="1538023" y="565740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B4ABD50D-E450-75C4-998F-3C9760A625EF}"/>
              </a:ext>
            </a:extLst>
          </p:cNvPr>
          <p:cNvSpPr txBox="1"/>
          <p:nvPr/>
        </p:nvSpPr>
        <p:spPr>
          <a:xfrm>
            <a:off x="2632364" y="2369127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64C86B3-DA92-FEA3-2787-7BF1F40977EC}"/>
              </a:ext>
            </a:extLst>
          </p:cNvPr>
          <p:cNvSpPr txBox="1"/>
          <p:nvPr/>
        </p:nvSpPr>
        <p:spPr>
          <a:xfrm>
            <a:off x="5297331" y="2369127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8D3A89E-F671-3FC1-B1BA-50C8CD1BFA98}"/>
              </a:ext>
            </a:extLst>
          </p:cNvPr>
          <p:cNvSpPr txBox="1"/>
          <p:nvPr/>
        </p:nvSpPr>
        <p:spPr>
          <a:xfrm>
            <a:off x="8953500" y="2837139"/>
            <a:ext cx="181148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2</a:t>
            </a:r>
            <a:endParaRPr lang="zh-CN" altLang="en-US" b="1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C1E98434-2E7E-EFF0-ECD0-300A6E5538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25975" y="4411377"/>
            <a:ext cx="3956801" cy="1516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5855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47A8737-6B03-C719-9A16-CEA7DD5B116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8585201" y="2418080"/>
            <a:ext cx="3337098" cy="1314376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34D7E0E-5FEB-E428-A481-054EF5FF4F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7591" y="1748239"/>
            <a:ext cx="3845976" cy="154585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A9F5DDF-EE20-5F6D-56F9-D8080C39C1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76430" y="1964437"/>
            <a:ext cx="3725363" cy="125243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5878A35-AFBF-36F7-7013-E5D32E7B4A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44282" y="3551521"/>
            <a:ext cx="3769212" cy="116759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1B967F2B-FB62-696A-D39E-EBCCAA7491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90861" y="3551521"/>
            <a:ext cx="3427525" cy="114250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97A65C1-824A-BE28-2058-4AC3D000058D}"/>
              </a:ext>
            </a:extLst>
          </p:cNvPr>
          <p:cNvSpPr txBox="1"/>
          <p:nvPr/>
        </p:nvSpPr>
        <p:spPr>
          <a:xfrm>
            <a:off x="15146" y="2431682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25kd</a:t>
            </a:r>
            <a:endParaRPr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E17448D-A46D-90EB-1421-53D11451A095}"/>
              </a:ext>
            </a:extLst>
          </p:cNvPr>
          <p:cNvSpPr txBox="1"/>
          <p:nvPr/>
        </p:nvSpPr>
        <p:spPr>
          <a:xfrm>
            <a:off x="15147" y="2890411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8119793-1FBA-C4F4-9ED8-1B8163DB293D}"/>
              </a:ext>
            </a:extLst>
          </p:cNvPr>
          <p:cNvSpPr txBox="1"/>
          <p:nvPr/>
        </p:nvSpPr>
        <p:spPr>
          <a:xfrm>
            <a:off x="-24696" y="414304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96ADB88-6DCE-D012-F1BC-47D2A9DA6785}"/>
              </a:ext>
            </a:extLst>
          </p:cNvPr>
          <p:cNvSpPr txBox="1"/>
          <p:nvPr/>
        </p:nvSpPr>
        <p:spPr>
          <a:xfrm>
            <a:off x="-34548" y="3891566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9A2B732-D94E-C33D-11C7-25C18BBD4BA0}"/>
              </a:ext>
            </a:extLst>
          </p:cNvPr>
          <p:cNvSpPr txBox="1"/>
          <p:nvPr/>
        </p:nvSpPr>
        <p:spPr>
          <a:xfrm>
            <a:off x="-14843" y="3593671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AA98A1A7-1225-CE8B-BD74-08E1A6117A24}"/>
              </a:ext>
            </a:extLst>
          </p:cNvPr>
          <p:cNvCxnSpPr>
            <a:cxnSpLocks/>
          </p:cNvCxnSpPr>
          <p:nvPr/>
        </p:nvCxnSpPr>
        <p:spPr>
          <a:xfrm>
            <a:off x="579718" y="2585570"/>
            <a:ext cx="405802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D9A7C505-9730-8002-45EB-77C0C5E59C1E}"/>
              </a:ext>
            </a:extLst>
          </p:cNvPr>
          <p:cNvCxnSpPr>
            <a:cxnSpLocks/>
          </p:cNvCxnSpPr>
          <p:nvPr/>
        </p:nvCxnSpPr>
        <p:spPr>
          <a:xfrm>
            <a:off x="555473" y="3044299"/>
            <a:ext cx="322118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9D623906-E1A2-6AC4-868A-558CC4E632B5}"/>
              </a:ext>
            </a:extLst>
          </p:cNvPr>
          <p:cNvCxnSpPr/>
          <p:nvPr/>
        </p:nvCxnSpPr>
        <p:spPr>
          <a:xfrm>
            <a:off x="600563" y="373245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0AD2E0D9-EB62-3E51-1FA1-4E3D66B0C821}"/>
              </a:ext>
            </a:extLst>
          </p:cNvPr>
          <p:cNvCxnSpPr/>
          <p:nvPr/>
        </p:nvCxnSpPr>
        <p:spPr>
          <a:xfrm>
            <a:off x="579717" y="403832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77278A50-CAC7-0048-141D-7D7E8A00BD26}"/>
              </a:ext>
            </a:extLst>
          </p:cNvPr>
          <p:cNvCxnSpPr/>
          <p:nvPr/>
        </p:nvCxnSpPr>
        <p:spPr>
          <a:xfrm>
            <a:off x="579717" y="428466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E50F6351-E99C-2FD3-6032-1B2E19D476D9}"/>
              </a:ext>
            </a:extLst>
          </p:cNvPr>
          <p:cNvSpPr txBox="1"/>
          <p:nvPr/>
        </p:nvSpPr>
        <p:spPr>
          <a:xfrm>
            <a:off x="9500754" y="1706481"/>
            <a:ext cx="196388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3</a:t>
            </a:r>
            <a:endParaRPr lang="en-US" altLang="zh-CN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789E614-D18A-C20D-E9E7-514612F8814D}"/>
              </a:ext>
            </a:extLst>
          </p:cNvPr>
          <p:cNvSpPr txBox="1"/>
          <p:nvPr/>
        </p:nvSpPr>
        <p:spPr>
          <a:xfrm>
            <a:off x="2446713" y="1260459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B852E32-0869-B126-E7D0-58B267318F66}"/>
              </a:ext>
            </a:extLst>
          </p:cNvPr>
          <p:cNvSpPr txBox="1"/>
          <p:nvPr/>
        </p:nvSpPr>
        <p:spPr>
          <a:xfrm>
            <a:off x="6079502" y="1389686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6037304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65CF47C-ADB2-791C-4018-E60A9F2CE70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8193438" y="2547527"/>
            <a:ext cx="3638709" cy="2921145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293E9CE-4E76-B306-ED96-E4544E137F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4356" y="5085951"/>
            <a:ext cx="3243843" cy="76544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841DA82-94F8-C8B8-1641-0614AA6587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93921" y="5085951"/>
            <a:ext cx="3301139" cy="77016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48CEC7A-D829-9A0D-AB0C-1CB8448E0E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49126" y="5974259"/>
            <a:ext cx="3301139" cy="6558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AD4BA72-79E7-3C67-0B15-143ABCD8110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32284" y="5851394"/>
            <a:ext cx="3127989" cy="82045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4339906-FA07-6C55-901F-75BE22EEA7F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64540" y="4328898"/>
            <a:ext cx="3195734" cy="71904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92D680D8-35B5-5149-732D-E90840AC542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93921" y="4305293"/>
            <a:ext cx="3064805" cy="780658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AF6C057B-1880-1048-8002-7E0EE56B0D1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14014" y="1499085"/>
            <a:ext cx="3363971" cy="81687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773E6A21-B989-0AAF-2DB0-A47270E8C42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98409" y="1499085"/>
            <a:ext cx="3195735" cy="66526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36919FF-FA90-382E-DDB0-B223BE733F7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98409" y="2323080"/>
            <a:ext cx="3067245" cy="60670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1DA92517-AFA2-AA94-C44B-535DF3A141B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14014" y="2389249"/>
            <a:ext cx="3301139" cy="745637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ACE2418F-3FFC-9205-ECEF-72B67C9987A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00520" y="3392215"/>
            <a:ext cx="3314633" cy="747166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AA6EB22-943D-FE7C-EED8-4D63C43D180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64540" y="3203290"/>
            <a:ext cx="3064805" cy="821599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A98E319E-23DA-F8DC-5280-6342B609D339}"/>
              </a:ext>
            </a:extLst>
          </p:cNvPr>
          <p:cNvSpPr txBox="1"/>
          <p:nvPr/>
        </p:nvSpPr>
        <p:spPr>
          <a:xfrm>
            <a:off x="359853" y="159974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39E1505-B8C7-DCF2-9E59-BBD8610776DE}"/>
              </a:ext>
            </a:extLst>
          </p:cNvPr>
          <p:cNvSpPr txBox="1"/>
          <p:nvPr/>
        </p:nvSpPr>
        <p:spPr>
          <a:xfrm>
            <a:off x="359853" y="238924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19F311F-96CE-C0BE-870E-515039C093FD}"/>
              </a:ext>
            </a:extLst>
          </p:cNvPr>
          <p:cNvSpPr txBox="1"/>
          <p:nvPr/>
        </p:nvSpPr>
        <p:spPr>
          <a:xfrm>
            <a:off x="359853" y="3312376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FF10D45-F1FA-5927-F424-5EEEA5DB0842}"/>
              </a:ext>
            </a:extLst>
          </p:cNvPr>
          <p:cNvSpPr txBox="1"/>
          <p:nvPr/>
        </p:nvSpPr>
        <p:spPr>
          <a:xfrm>
            <a:off x="359853" y="3622641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A07DDFA-9BC6-D774-531F-1F5F89668F75}"/>
              </a:ext>
            </a:extLst>
          </p:cNvPr>
          <p:cNvSpPr txBox="1"/>
          <p:nvPr/>
        </p:nvSpPr>
        <p:spPr>
          <a:xfrm>
            <a:off x="359853" y="2684211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3189232-F189-AC5B-69F5-9A2830DDC468}"/>
              </a:ext>
            </a:extLst>
          </p:cNvPr>
          <p:cNvSpPr txBox="1"/>
          <p:nvPr/>
        </p:nvSpPr>
        <p:spPr>
          <a:xfrm>
            <a:off x="359853" y="1856568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98D8E13-9303-57E2-1E49-16C11442D552}"/>
              </a:ext>
            </a:extLst>
          </p:cNvPr>
          <p:cNvSpPr txBox="1"/>
          <p:nvPr/>
        </p:nvSpPr>
        <p:spPr>
          <a:xfrm>
            <a:off x="359853" y="439549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8B4A819-BD27-7F40-FD1B-52077153FF26}"/>
              </a:ext>
            </a:extLst>
          </p:cNvPr>
          <p:cNvSpPr txBox="1"/>
          <p:nvPr/>
        </p:nvSpPr>
        <p:spPr>
          <a:xfrm>
            <a:off x="359853" y="470575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FFA33AC-4D38-12CC-A989-C3853CF83DC1}"/>
              </a:ext>
            </a:extLst>
          </p:cNvPr>
          <p:cNvSpPr txBox="1"/>
          <p:nvPr/>
        </p:nvSpPr>
        <p:spPr>
          <a:xfrm>
            <a:off x="359853" y="5533920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0657A70E-1D78-9416-1C77-E283CF5E24EC}"/>
              </a:ext>
            </a:extLst>
          </p:cNvPr>
          <p:cNvCxnSpPr/>
          <p:nvPr/>
        </p:nvCxnSpPr>
        <p:spPr>
          <a:xfrm>
            <a:off x="895286" y="568780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8A195AF2-00FE-90AE-A3E4-A75478240669}"/>
              </a:ext>
            </a:extLst>
          </p:cNvPr>
          <p:cNvSpPr txBox="1"/>
          <p:nvPr/>
        </p:nvSpPr>
        <p:spPr>
          <a:xfrm>
            <a:off x="293257" y="640801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B875CF9-E438-6835-A86F-5685AF9F41C2}"/>
              </a:ext>
            </a:extLst>
          </p:cNvPr>
          <p:cNvSpPr txBox="1"/>
          <p:nvPr/>
        </p:nvSpPr>
        <p:spPr>
          <a:xfrm>
            <a:off x="286277" y="614953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526423F-E468-C6DB-8D8D-CFC78CEDDC92}"/>
              </a:ext>
            </a:extLst>
          </p:cNvPr>
          <p:cNvSpPr txBox="1"/>
          <p:nvPr/>
        </p:nvSpPr>
        <p:spPr>
          <a:xfrm>
            <a:off x="286277" y="589104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FE6B8C69-BD7B-30A8-3BDA-6F3F23A6A01C}"/>
              </a:ext>
            </a:extLst>
          </p:cNvPr>
          <p:cNvCxnSpPr/>
          <p:nvPr/>
        </p:nvCxnSpPr>
        <p:spPr>
          <a:xfrm>
            <a:off x="887818" y="604493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8073B445-F39D-BAB9-1377-7BC9919694FD}"/>
              </a:ext>
            </a:extLst>
          </p:cNvPr>
          <p:cNvCxnSpPr/>
          <p:nvPr/>
        </p:nvCxnSpPr>
        <p:spPr>
          <a:xfrm>
            <a:off x="887818" y="630341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5E4649DF-5864-61D0-4F40-E393D2348BF9}"/>
              </a:ext>
            </a:extLst>
          </p:cNvPr>
          <p:cNvCxnSpPr/>
          <p:nvPr/>
        </p:nvCxnSpPr>
        <p:spPr>
          <a:xfrm>
            <a:off x="887818" y="657575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1C3A089E-7A86-603F-9945-E0DD1AE3BAB6}"/>
              </a:ext>
            </a:extLst>
          </p:cNvPr>
          <p:cNvCxnSpPr/>
          <p:nvPr/>
        </p:nvCxnSpPr>
        <p:spPr>
          <a:xfrm>
            <a:off x="887818" y="460022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C2994D61-C5A8-C54F-4ACB-C9FDFCB4C413}"/>
              </a:ext>
            </a:extLst>
          </p:cNvPr>
          <p:cNvCxnSpPr/>
          <p:nvPr/>
        </p:nvCxnSpPr>
        <p:spPr>
          <a:xfrm>
            <a:off x="880350" y="495735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834815BD-25FA-6F10-6A49-9D490DD09FDA}"/>
              </a:ext>
            </a:extLst>
          </p:cNvPr>
          <p:cNvCxnSpPr/>
          <p:nvPr/>
        </p:nvCxnSpPr>
        <p:spPr>
          <a:xfrm>
            <a:off x="895286" y="348493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643E9E8C-842C-A93A-FAAA-5FBB10C104B6}"/>
              </a:ext>
            </a:extLst>
          </p:cNvPr>
          <p:cNvCxnSpPr/>
          <p:nvPr/>
        </p:nvCxnSpPr>
        <p:spPr>
          <a:xfrm>
            <a:off x="887818" y="3842063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779AD8B9-6B3B-4078-F239-9E43476C6926}"/>
              </a:ext>
            </a:extLst>
          </p:cNvPr>
          <p:cNvCxnSpPr/>
          <p:nvPr/>
        </p:nvCxnSpPr>
        <p:spPr>
          <a:xfrm>
            <a:off x="895286" y="248740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F59B6BE7-0658-6183-CC0E-E2F87F8BA273}"/>
              </a:ext>
            </a:extLst>
          </p:cNvPr>
          <p:cNvCxnSpPr/>
          <p:nvPr/>
        </p:nvCxnSpPr>
        <p:spPr>
          <a:xfrm>
            <a:off x="887818" y="284453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E42421AC-5780-6E7E-4B29-04D97404FF0E}"/>
              </a:ext>
            </a:extLst>
          </p:cNvPr>
          <p:cNvCxnSpPr/>
          <p:nvPr/>
        </p:nvCxnSpPr>
        <p:spPr>
          <a:xfrm>
            <a:off x="895286" y="173233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87772813-F56C-7593-66F8-95193FDCCB1E}"/>
              </a:ext>
            </a:extLst>
          </p:cNvPr>
          <p:cNvCxnSpPr/>
          <p:nvPr/>
        </p:nvCxnSpPr>
        <p:spPr>
          <a:xfrm>
            <a:off x="887818" y="2089463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F3236239-6BDA-6776-A9FD-BBF84DE63150}"/>
              </a:ext>
            </a:extLst>
          </p:cNvPr>
          <p:cNvSpPr txBox="1"/>
          <p:nvPr/>
        </p:nvSpPr>
        <p:spPr>
          <a:xfrm>
            <a:off x="2202873" y="1001089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CA30F1F-B062-D693-7B03-CAAFAD198D57}"/>
              </a:ext>
            </a:extLst>
          </p:cNvPr>
          <p:cNvSpPr txBox="1"/>
          <p:nvPr/>
        </p:nvSpPr>
        <p:spPr>
          <a:xfrm>
            <a:off x="5893077" y="1001089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80596DF3-F14D-5176-A2A0-70EE82FA2C08}"/>
              </a:ext>
            </a:extLst>
          </p:cNvPr>
          <p:cNvSpPr txBox="1"/>
          <p:nvPr/>
        </p:nvSpPr>
        <p:spPr>
          <a:xfrm>
            <a:off x="9101371" y="1732335"/>
            <a:ext cx="174673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6B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2313039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EF349C5E-BEE8-F7C5-CC94-B0844C8F5D8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8087242" y="2424197"/>
            <a:ext cx="3878668" cy="2156262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F547AEE-5920-2B26-07F4-7B2C685CB0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79425" y="5459312"/>
            <a:ext cx="3266895" cy="97403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9E3D38E-6267-0502-E476-D836F910DA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72302" y="5459312"/>
            <a:ext cx="2685004" cy="81835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CD5082F-45FB-14A0-B137-532038D0FE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56483" y="3354806"/>
            <a:ext cx="3322313" cy="70111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4B322E9-F5EE-1831-F142-DD2E7E7D59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59135" y="3265077"/>
            <a:ext cx="2858185" cy="81458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E86F9AE-4714-4985-32D9-E810E214A0E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59135" y="4251814"/>
            <a:ext cx="2858185" cy="91946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ACFAFC02-58D6-477E-0E68-B0AA845183C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46947" y="4207902"/>
            <a:ext cx="3331849" cy="109942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FA0BC08-A5DE-B0C8-D8CC-66B32B124B5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34843" y="2408811"/>
            <a:ext cx="3322313" cy="85626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B1FECBD-FEFF-DB87-FE99-46B42D5A72F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36448" y="2424197"/>
            <a:ext cx="2989633" cy="63911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826E560A-1DD3-F052-DFAE-F696846412A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59135" y="1451672"/>
            <a:ext cx="2858185" cy="756795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77B7373D-2DD4-327D-E4A5-768A67C5116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34843" y="1405976"/>
            <a:ext cx="3322313" cy="802491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F904A4B0-82A1-4B10-6C70-094D62E9A5BA}"/>
              </a:ext>
            </a:extLst>
          </p:cNvPr>
          <p:cNvSpPr txBox="1"/>
          <p:nvPr/>
        </p:nvSpPr>
        <p:spPr>
          <a:xfrm>
            <a:off x="395044" y="1496038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CCC836A-B438-3F95-7F9E-D81D9E1D8793}"/>
              </a:ext>
            </a:extLst>
          </p:cNvPr>
          <p:cNvSpPr txBox="1"/>
          <p:nvPr/>
        </p:nvSpPr>
        <p:spPr>
          <a:xfrm>
            <a:off x="577992" y="259777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0260757-FF9A-A7AE-4436-381E82EB1883}"/>
              </a:ext>
            </a:extLst>
          </p:cNvPr>
          <p:cNvSpPr txBox="1"/>
          <p:nvPr/>
        </p:nvSpPr>
        <p:spPr>
          <a:xfrm>
            <a:off x="533918" y="341025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2256705-FDE8-4CD1-C3D4-6C6310DC438A}"/>
              </a:ext>
            </a:extLst>
          </p:cNvPr>
          <p:cNvSpPr txBox="1"/>
          <p:nvPr/>
        </p:nvSpPr>
        <p:spPr>
          <a:xfrm>
            <a:off x="533918" y="372052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987C3B6-71DE-5850-6A36-9516A5A10FA7}"/>
              </a:ext>
            </a:extLst>
          </p:cNvPr>
          <p:cNvSpPr txBox="1"/>
          <p:nvPr/>
        </p:nvSpPr>
        <p:spPr>
          <a:xfrm>
            <a:off x="541386" y="279543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680AD5A-B50E-96F0-4A0A-14C986F49F62}"/>
              </a:ext>
            </a:extLst>
          </p:cNvPr>
          <p:cNvSpPr txBox="1"/>
          <p:nvPr/>
        </p:nvSpPr>
        <p:spPr>
          <a:xfrm>
            <a:off x="395043" y="1722612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4CE42A9-7854-B303-8D4E-C47D580F1680}"/>
              </a:ext>
            </a:extLst>
          </p:cNvPr>
          <p:cNvSpPr txBox="1"/>
          <p:nvPr/>
        </p:nvSpPr>
        <p:spPr>
          <a:xfrm>
            <a:off x="512205" y="5774573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1BC60D7-4190-2287-718D-59465D880F3B}"/>
              </a:ext>
            </a:extLst>
          </p:cNvPr>
          <p:cNvSpPr txBox="1"/>
          <p:nvPr/>
        </p:nvSpPr>
        <p:spPr>
          <a:xfrm>
            <a:off x="505225" y="5632165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3D621AD-F3A5-1298-B095-6FC15D4C0DDB}"/>
              </a:ext>
            </a:extLst>
          </p:cNvPr>
          <p:cNvSpPr txBox="1"/>
          <p:nvPr/>
        </p:nvSpPr>
        <p:spPr>
          <a:xfrm>
            <a:off x="518156" y="5468794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71F5F812-C8DE-0FA0-57F8-3585ADF5E2FF}"/>
              </a:ext>
            </a:extLst>
          </p:cNvPr>
          <p:cNvCxnSpPr/>
          <p:nvPr/>
        </p:nvCxnSpPr>
        <p:spPr>
          <a:xfrm>
            <a:off x="1119697" y="562268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FE917F26-1F8C-3993-A86A-03A73EE2F782}"/>
              </a:ext>
            </a:extLst>
          </p:cNvPr>
          <p:cNvCxnSpPr/>
          <p:nvPr/>
        </p:nvCxnSpPr>
        <p:spPr>
          <a:xfrm>
            <a:off x="1106766" y="5786053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09B2D229-16D7-E6F0-2E6F-6F4CE3D1CD0C}"/>
              </a:ext>
            </a:extLst>
          </p:cNvPr>
          <p:cNvCxnSpPr/>
          <p:nvPr/>
        </p:nvCxnSpPr>
        <p:spPr>
          <a:xfrm>
            <a:off x="1106766" y="594231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A2223DB3-22C6-D178-61C0-EF7452E250BB}"/>
              </a:ext>
            </a:extLst>
          </p:cNvPr>
          <p:cNvCxnSpPr/>
          <p:nvPr/>
        </p:nvCxnSpPr>
        <p:spPr>
          <a:xfrm>
            <a:off x="1069351" y="358281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7C48DC49-404F-917F-3F1A-34A5B654D54B}"/>
              </a:ext>
            </a:extLst>
          </p:cNvPr>
          <p:cNvCxnSpPr/>
          <p:nvPr/>
        </p:nvCxnSpPr>
        <p:spPr>
          <a:xfrm>
            <a:off x="1061883" y="393994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966AB627-9DCC-6A46-BDE0-BB2CC9F909EA}"/>
              </a:ext>
            </a:extLst>
          </p:cNvPr>
          <p:cNvCxnSpPr/>
          <p:nvPr/>
        </p:nvCxnSpPr>
        <p:spPr>
          <a:xfrm>
            <a:off x="1113425" y="269593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84E033C1-42FB-36F4-3C75-6708951B8D01}"/>
              </a:ext>
            </a:extLst>
          </p:cNvPr>
          <p:cNvCxnSpPr/>
          <p:nvPr/>
        </p:nvCxnSpPr>
        <p:spPr>
          <a:xfrm>
            <a:off x="1069351" y="295576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DEB4C630-21FA-E830-EE63-A1AC625EC734}"/>
              </a:ext>
            </a:extLst>
          </p:cNvPr>
          <p:cNvCxnSpPr/>
          <p:nvPr/>
        </p:nvCxnSpPr>
        <p:spPr>
          <a:xfrm>
            <a:off x="928846" y="161967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CD45DAAE-D46E-DE39-80DD-2D1EC6511B81}"/>
              </a:ext>
            </a:extLst>
          </p:cNvPr>
          <p:cNvCxnSpPr/>
          <p:nvPr/>
        </p:nvCxnSpPr>
        <p:spPr>
          <a:xfrm>
            <a:off x="864041" y="180381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1B6066A4-F166-7B89-0121-9982D39C7DC2}"/>
              </a:ext>
            </a:extLst>
          </p:cNvPr>
          <p:cNvSpPr txBox="1"/>
          <p:nvPr/>
        </p:nvSpPr>
        <p:spPr>
          <a:xfrm>
            <a:off x="571333" y="486524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3B119588-FE18-79AB-D5BA-2B0313E67F0A}"/>
              </a:ext>
            </a:extLst>
          </p:cNvPr>
          <p:cNvCxnSpPr/>
          <p:nvPr/>
        </p:nvCxnSpPr>
        <p:spPr>
          <a:xfrm>
            <a:off x="1106766" y="501913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628BDF94-C7D6-3AFF-A5FA-BECEA1ACFAB9}"/>
              </a:ext>
            </a:extLst>
          </p:cNvPr>
          <p:cNvSpPr txBox="1"/>
          <p:nvPr/>
        </p:nvSpPr>
        <p:spPr>
          <a:xfrm>
            <a:off x="9099921" y="1137837"/>
            <a:ext cx="142378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Figure6C</a:t>
            </a:r>
            <a:endParaRPr lang="zh-CN" altLang="en-US" sz="2400" b="1" dirty="0"/>
          </a:p>
          <a:p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42061FD-6D9D-8125-3CD8-42F43F2CAC30}"/>
              </a:ext>
            </a:extLst>
          </p:cNvPr>
          <p:cNvSpPr txBox="1"/>
          <p:nvPr/>
        </p:nvSpPr>
        <p:spPr>
          <a:xfrm>
            <a:off x="2405796" y="991780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DCE8E81-6FF5-2BA2-E5C9-F9869F211441}"/>
              </a:ext>
            </a:extLst>
          </p:cNvPr>
          <p:cNvSpPr txBox="1"/>
          <p:nvPr/>
        </p:nvSpPr>
        <p:spPr>
          <a:xfrm>
            <a:off x="6096000" y="991780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2749735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92BB78E7-3001-19B6-1344-5BCAB90DC02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7650296" y="2148385"/>
            <a:ext cx="4587500" cy="3103605"/>
          </a:xfr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3A54C9A-BE7E-C132-ABD6-A897EEA91A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35739" y="5947866"/>
            <a:ext cx="3320521" cy="76654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72E667E-8053-4944-64DD-3E54C91CE1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07072" y="5947866"/>
            <a:ext cx="3148448" cy="8142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1C5B28A-61B5-964D-4B30-BFB5895D84A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70205" y="4821231"/>
            <a:ext cx="3056065" cy="89574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A55F976-68AA-179C-EB03-7EC021AA11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12814" y="3084057"/>
            <a:ext cx="3022724" cy="91761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0F7BA8E-A3F5-8704-5015-55DE5256888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41058" y="3107076"/>
            <a:ext cx="3056065" cy="98174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6A1F097-5E7F-2362-42D4-549D0C2CA2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12947" y="2071114"/>
            <a:ext cx="3118411" cy="77245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07AA1A4-955D-7E37-0FF6-00D96132B85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17126" y="1943298"/>
            <a:ext cx="3118412" cy="914422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5AB2FB2-51B7-4DCA-02DC-A8536AC270E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80657" y="975481"/>
            <a:ext cx="3148448" cy="98790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74BB8B26-D5CC-AB6F-DEB2-A541FF34C2F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26595" y="955392"/>
            <a:ext cx="3008943" cy="76156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A0944C62-EB43-C87D-9849-CBFE44B72E0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35739" y="4789559"/>
            <a:ext cx="3056066" cy="865366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C967C13-12E8-3601-DEFA-E92F286AB18D}"/>
              </a:ext>
            </a:extLst>
          </p:cNvPr>
          <p:cNvSpPr txBox="1"/>
          <p:nvPr/>
        </p:nvSpPr>
        <p:spPr>
          <a:xfrm>
            <a:off x="299502" y="104045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FCB915F-7FBA-8C6E-7B55-3A9B40EA3B34}"/>
              </a:ext>
            </a:extLst>
          </p:cNvPr>
          <p:cNvSpPr txBox="1"/>
          <p:nvPr/>
        </p:nvSpPr>
        <p:spPr>
          <a:xfrm>
            <a:off x="254316" y="226420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5CF7A3-8095-C4D0-3E89-32C0CA2E558D}"/>
              </a:ext>
            </a:extLst>
          </p:cNvPr>
          <p:cNvSpPr txBox="1"/>
          <p:nvPr/>
        </p:nvSpPr>
        <p:spPr>
          <a:xfrm>
            <a:off x="242050" y="3425388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368EB39-1A9E-C873-9D6E-AA819E6CE4F5}"/>
              </a:ext>
            </a:extLst>
          </p:cNvPr>
          <p:cNvSpPr txBox="1"/>
          <p:nvPr/>
        </p:nvSpPr>
        <p:spPr>
          <a:xfrm>
            <a:off x="242050" y="373565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F6C4BAD-4179-9868-A9B1-F6D81DD2814F}"/>
              </a:ext>
            </a:extLst>
          </p:cNvPr>
          <p:cNvSpPr txBox="1"/>
          <p:nvPr/>
        </p:nvSpPr>
        <p:spPr>
          <a:xfrm>
            <a:off x="254316" y="255916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CE079F3-FA9D-5375-5D84-0DACE6AFDFB9}"/>
              </a:ext>
            </a:extLst>
          </p:cNvPr>
          <p:cNvSpPr txBox="1"/>
          <p:nvPr/>
        </p:nvSpPr>
        <p:spPr>
          <a:xfrm>
            <a:off x="299502" y="129728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B104A85-D206-9A87-4F72-60DD5FE92FA0}"/>
              </a:ext>
            </a:extLst>
          </p:cNvPr>
          <p:cNvSpPr txBox="1"/>
          <p:nvPr/>
        </p:nvSpPr>
        <p:spPr>
          <a:xfrm>
            <a:off x="232906" y="6384791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DE80D12-8170-B70E-613D-CF4287E01C5B}"/>
              </a:ext>
            </a:extLst>
          </p:cNvPr>
          <p:cNvSpPr txBox="1"/>
          <p:nvPr/>
        </p:nvSpPr>
        <p:spPr>
          <a:xfrm>
            <a:off x="225926" y="618385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68329A3-EA67-94AD-0B57-6E23517A383B}"/>
              </a:ext>
            </a:extLst>
          </p:cNvPr>
          <p:cNvSpPr txBox="1"/>
          <p:nvPr/>
        </p:nvSpPr>
        <p:spPr>
          <a:xfrm>
            <a:off x="228145" y="598899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82DCCB7D-6182-E3DB-DBB7-EF0B3BF2271F}"/>
              </a:ext>
            </a:extLst>
          </p:cNvPr>
          <p:cNvCxnSpPr/>
          <p:nvPr/>
        </p:nvCxnSpPr>
        <p:spPr>
          <a:xfrm>
            <a:off x="829686" y="614288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B31D127E-F408-A162-EEFF-3ABC3B0AEC04}"/>
              </a:ext>
            </a:extLst>
          </p:cNvPr>
          <p:cNvCxnSpPr/>
          <p:nvPr/>
        </p:nvCxnSpPr>
        <p:spPr>
          <a:xfrm>
            <a:off x="827467" y="633774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C9C76C1A-D3F5-9145-99B5-3A74F6480531}"/>
              </a:ext>
            </a:extLst>
          </p:cNvPr>
          <p:cNvCxnSpPr/>
          <p:nvPr/>
        </p:nvCxnSpPr>
        <p:spPr>
          <a:xfrm>
            <a:off x="827467" y="655253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FF12463D-45BE-3576-D131-7D721A397440}"/>
              </a:ext>
            </a:extLst>
          </p:cNvPr>
          <p:cNvCxnSpPr/>
          <p:nvPr/>
        </p:nvCxnSpPr>
        <p:spPr>
          <a:xfrm>
            <a:off x="777483" y="359794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A40885B5-46F8-38B1-A37F-95708F1E72C5}"/>
              </a:ext>
            </a:extLst>
          </p:cNvPr>
          <p:cNvCxnSpPr/>
          <p:nvPr/>
        </p:nvCxnSpPr>
        <p:spPr>
          <a:xfrm>
            <a:off x="770015" y="395507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53BD633F-D5C1-0931-8C4B-7F3B754BCCCC}"/>
              </a:ext>
            </a:extLst>
          </p:cNvPr>
          <p:cNvCxnSpPr/>
          <p:nvPr/>
        </p:nvCxnSpPr>
        <p:spPr>
          <a:xfrm>
            <a:off x="789749" y="236236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793F4316-BE11-7830-FA7D-E6E15C8B21FC}"/>
              </a:ext>
            </a:extLst>
          </p:cNvPr>
          <p:cNvCxnSpPr/>
          <p:nvPr/>
        </p:nvCxnSpPr>
        <p:spPr>
          <a:xfrm>
            <a:off x="782281" y="271949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B0A2F32A-DE3C-C856-9E2F-A5526ECB1AA4}"/>
              </a:ext>
            </a:extLst>
          </p:cNvPr>
          <p:cNvCxnSpPr/>
          <p:nvPr/>
        </p:nvCxnSpPr>
        <p:spPr>
          <a:xfrm>
            <a:off x="834935" y="117305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65A4103E-D88E-07E1-F483-B66EB7581625}"/>
              </a:ext>
            </a:extLst>
          </p:cNvPr>
          <p:cNvCxnSpPr/>
          <p:nvPr/>
        </p:nvCxnSpPr>
        <p:spPr>
          <a:xfrm>
            <a:off x="827467" y="153017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0197BB2B-2AF8-A024-BF64-3C9246FEB554}"/>
              </a:ext>
            </a:extLst>
          </p:cNvPr>
          <p:cNvSpPr txBox="1"/>
          <p:nvPr/>
        </p:nvSpPr>
        <p:spPr>
          <a:xfrm>
            <a:off x="253230" y="506838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7A0E733-2361-3FC3-A393-D27F5A86BF42}"/>
              </a:ext>
            </a:extLst>
          </p:cNvPr>
          <p:cNvSpPr txBox="1"/>
          <p:nvPr/>
        </p:nvSpPr>
        <p:spPr>
          <a:xfrm>
            <a:off x="253230" y="532521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CE8B86B6-61C9-C867-F227-BB6D48550DC3}"/>
              </a:ext>
            </a:extLst>
          </p:cNvPr>
          <p:cNvCxnSpPr/>
          <p:nvPr/>
        </p:nvCxnSpPr>
        <p:spPr>
          <a:xfrm>
            <a:off x="788663" y="520098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49FDED39-B893-2935-403D-FF2B4BAFE30B}"/>
              </a:ext>
            </a:extLst>
          </p:cNvPr>
          <p:cNvCxnSpPr/>
          <p:nvPr/>
        </p:nvCxnSpPr>
        <p:spPr>
          <a:xfrm>
            <a:off x="781195" y="555810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>
            <a:extLst>
              <a:ext uri="{FF2B5EF4-FFF2-40B4-BE49-F238E27FC236}">
                <a16:creationId xmlns:a16="http://schemas.microsoft.com/office/drawing/2014/main" id="{55E2EE30-E00D-39C6-B63A-E2F7980D495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14252" y="4038379"/>
            <a:ext cx="2468640" cy="76654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47FA5CD-C27A-DBA0-A6C5-83370D93A1B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11881" y="4045085"/>
            <a:ext cx="2359007" cy="67648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829B9F55-AA36-076D-9B01-734DE14DA2D5}"/>
              </a:ext>
            </a:extLst>
          </p:cNvPr>
          <p:cNvSpPr txBox="1"/>
          <p:nvPr/>
        </p:nvSpPr>
        <p:spPr>
          <a:xfrm>
            <a:off x="249518" y="454445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D9749F46-C4E5-B9D5-F6CD-FEEDE8992F1D}"/>
              </a:ext>
            </a:extLst>
          </p:cNvPr>
          <p:cNvCxnSpPr/>
          <p:nvPr/>
        </p:nvCxnSpPr>
        <p:spPr>
          <a:xfrm>
            <a:off x="784951" y="469834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FAFB79FD-6B15-E242-784D-61E36E5FB6AE}"/>
              </a:ext>
            </a:extLst>
          </p:cNvPr>
          <p:cNvSpPr txBox="1"/>
          <p:nvPr/>
        </p:nvSpPr>
        <p:spPr>
          <a:xfrm>
            <a:off x="9182700" y="1143395"/>
            <a:ext cx="1391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Figure6E</a:t>
            </a:r>
            <a:endParaRPr lang="zh-CN" altLang="en-US" sz="2400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05D5AF2-D264-F6C6-2129-0DF4D51889D8}"/>
              </a:ext>
            </a:extLst>
          </p:cNvPr>
          <p:cNvSpPr txBox="1"/>
          <p:nvPr/>
        </p:nvSpPr>
        <p:spPr>
          <a:xfrm>
            <a:off x="2247954" y="507215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960EFAF-5613-4FC6-E55D-B571E10B51CB}"/>
              </a:ext>
            </a:extLst>
          </p:cNvPr>
          <p:cNvSpPr txBox="1"/>
          <p:nvPr/>
        </p:nvSpPr>
        <p:spPr>
          <a:xfrm>
            <a:off x="5404163" y="526750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137447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FAD18E78-8FA1-E862-DD66-E0116A009A3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7762404" y="3524477"/>
            <a:ext cx="3709159" cy="2353687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32520B1-2676-8F21-599A-F67725FDFA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0993" y="5381018"/>
            <a:ext cx="2755581" cy="68889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CEAAB35-DFE3-7332-F501-A7EBFAD563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86667" y="5362228"/>
            <a:ext cx="2853008" cy="72707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365D60E-99AC-907C-0265-167CCB833F3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50993" y="4413394"/>
            <a:ext cx="2755581" cy="88822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3371EBF-E5A2-306E-8B01-D0AC69ABF4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0993" y="3524477"/>
            <a:ext cx="2856466" cy="77317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1B90A6C-45DC-D2D1-90A1-DB15BEE0048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00839" y="3473262"/>
            <a:ext cx="2856466" cy="83219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37E66772-D893-75B8-F17C-3059E7C1BE6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81997" y="2643639"/>
            <a:ext cx="2950154" cy="661717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DDC5490-9844-070C-B69F-EDDB434F5E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00839" y="2550403"/>
            <a:ext cx="2853007" cy="84819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8B5ADF6B-3200-4DFD-FA81-0B78C2AA6EB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00839" y="1546748"/>
            <a:ext cx="2800617" cy="75262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12B5644D-4824-76A8-759C-184FF307BD7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81997" y="1546748"/>
            <a:ext cx="2950154" cy="763746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A3EE81F4-F554-0757-C856-86FE60A713D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00839" y="4413394"/>
            <a:ext cx="2638515" cy="78428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0D63DC99-5B1E-1F5F-3BC4-122F4D88626F}"/>
              </a:ext>
            </a:extLst>
          </p:cNvPr>
          <p:cNvSpPr txBox="1"/>
          <p:nvPr/>
        </p:nvSpPr>
        <p:spPr>
          <a:xfrm>
            <a:off x="570149" y="1464106"/>
            <a:ext cx="585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3CFF36D-A437-B7B3-9A83-4C958C7C0B48}"/>
              </a:ext>
            </a:extLst>
          </p:cNvPr>
          <p:cNvSpPr txBox="1"/>
          <p:nvPr/>
        </p:nvSpPr>
        <p:spPr>
          <a:xfrm>
            <a:off x="570194" y="2718246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B40486B-339D-2905-3D38-20EF934CF71C}"/>
              </a:ext>
            </a:extLst>
          </p:cNvPr>
          <p:cNvSpPr txBox="1"/>
          <p:nvPr/>
        </p:nvSpPr>
        <p:spPr>
          <a:xfrm>
            <a:off x="532734" y="373764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F41518E-267E-F1DD-A0AE-BB7D66E0C166}"/>
              </a:ext>
            </a:extLst>
          </p:cNvPr>
          <p:cNvSpPr txBox="1"/>
          <p:nvPr/>
        </p:nvSpPr>
        <p:spPr>
          <a:xfrm>
            <a:off x="570149" y="4047908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C1945A2-2A8E-C2D0-3132-E68FD967C246}"/>
              </a:ext>
            </a:extLst>
          </p:cNvPr>
          <p:cNvSpPr txBox="1"/>
          <p:nvPr/>
        </p:nvSpPr>
        <p:spPr>
          <a:xfrm>
            <a:off x="533588" y="2978252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32B2515-A7BF-C4B1-8687-F121BB2C7E09}"/>
              </a:ext>
            </a:extLst>
          </p:cNvPr>
          <p:cNvSpPr txBox="1"/>
          <p:nvPr/>
        </p:nvSpPr>
        <p:spPr>
          <a:xfrm>
            <a:off x="570149" y="170517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FEBE765-3C61-3990-D7A1-A69413CA09E7}"/>
              </a:ext>
            </a:extLst>
          </p:cNvPr>
          <p:cNvSpPr txBox="1"/>
          <p:nvPr/>
        </p:nvSpPr>
        <p:spPr>
          <a:xfrm>
            <a:off x="561829" y="5660796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F02FB7E-2368-5D31-CAF8-7EFBFAF90500}"/>
              </a:ext>
            </a:extLst>
          </p:cNvPr>
          <p:cNvSpPr txBox="1"/>
          <p:nvPr/>
        </p:nvSpPr>
        <p:spPr>
          <a:xfrm>
            <a:off x="554849" y="551838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EB0B41E-2334-EC9B-A1A8-D3854BE1B4FA}"/>
              </a:ext>
            </a:extLst>
          </p:cNvPr>
          <p:cNvSpPr txBox="1"/>
          <p:nvPr/>
        </p:nvSpPr>
        <p:spPr>
          <a:xfrm>
            <a:off x="567780" y="535501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69DD08B7-953B-6751-4183-C67BDD20C5BB}"/>
              </a:ext>
            </a:extLst>
          </p:cNvPr>
          <p:cNvCxnSpPr/>
          <p:nvPr/>
        </p:nvCxnSpPr>
        <p:spPr>
          <a:xfrm>
            <a:off x="1169321" y="550890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A0E2FF07-910D-A755-F6FB-A67961E9EAC8}"/>
              </a:ext>
            </a:extLst>
          </p:cNvPr>
          <p:cNvCxnSpPr/>
          <p:nvPr/>
        </p:nvCxnSpPr>
        <p:spPr>
          <a:xfrm>
            <a:off x="1156390" y="567227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F73C07EA-0C38-53CD-2F43-974F9D6CC207}"/>
              </a:ext>
            </a:extLst>
          </p:cNvPr>
          <p:cNvCxnSpPr/>
          <p:nvPr/>
        </p:nvCxnSpPr>
        <p:spPr>
          <a:xfrm>
            <a:off x="1156390" y="5828539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E23B8CE6-E52B-F9EC-9B5B-21111F63416A}"/>
              </a:ext>
            </a:extLst>
          </p:cNvPr>
          <p:cNvCxnSpPr/>
          <p:nvPr/>
        </p:nvCxnSpPr>
        <p:spPr>
          <a:xfrm>
            <a:off x="1068167" y="391020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193F7161-0EFF-97D0-68C9-0EC842BE2A29}"/>
              </a:ext>
            </a:extLst>
          </p:cNvPr>
          <p:cNvCxnSpPr/>
          <p:nvPr/>
        </p:nvCxnSpPr>
        <p:spPr>
          <a:xfrm>
            <a:off x="1098114" y="426733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0085BCE3-4225-3790-BBAD-F25438B4063C}"/>
              </a:ext>
            </a:extLst>
          </p:cNvPr>
          <p:cNvCxnSpPr/>
          <p:nvPr/>
        </p:nvCxnSpPr>
        <p:spPr>
          <a:xfrm>
            <a:off x="1105627" y="2878749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F82CDF78-3FDB-AA15-352D-17857629DBF0}"/>
              </a:ext>
            </a:extLst>
          </p:cNvPr>
          <p:cNvCxnSpPr/>
          <p:nvPr/>
        </p:nvCxnSpPr>
        <p:spPr>
          <a:xfrm>
            <a:off x="1090646" y="313165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81EC527B-828A-0C09-49F4-81F17BB8A6A5}"/>
              </a:ext>
            </a:extLst>
          </p:cNvPr>
          <p:cNvCxnSpPr/>
          <p:nvPr/>
        </p:nvCxnSpPr>
        <p:spPr>
          <a:xfrm>
            <a:off x="1090646" y="166249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83818DE4-CCD9-E0AD-EF62-6B850C2B87CE}"/>
              </a:ext>
            </a:extLst>
          </p:cNvPr>
          <p:cNvCxnSpPr/>
          <p:nvPr/>
        </p:nvCxnSpPr>
        <p:spPr>
          <a:xfrm>
            <a:off x="1098114" y="189070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14ADF76-570E-177A-6D76-4B66BE90584B}"/>
              </a:ext>
            </a:extLst>
          </p:cNvPr>
          <p:cNvSpPr txBox="1"/>
          <p:nvPr/>
        </p:nvSpPr>
        <p:spPr>
          <a:xfrm>
            <a:off x="582718" y="4867558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6140454B-6D40-E1A3-DF5F-9CF05A4C38B9}"/>
              </a:ext>
            </a:extLst>
          </p:cNvPr>
          <p:cNvCxnSpPr/>
          <p:nvPr/>
        </p:nvCxnSpPr>
        <p:spPr>
          <a:xfrm>
            <a:off x="1118151" y="502144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A66AF745-25C8-7724-1680-7EC5DA70C5C6}"/>
              </a:ext>
            </a:extLst>
          </p:cNvPr>
          <p:cNvSpPr txBox="1"/>
          <p:nvPr/>
        </p:nvSpPr>
        <p:spPr>
          <a:xfrm>
            <a:off x="570194" y="451060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25kd</a:t>
            </a:r>
            <a:endParaRPr lang="zh-CN" altLang="en-US" sz="1400" b="1" dirty="0"/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A84DB330-BD1D-C7E6-FBCD-AEC858C5062D}"/>
              </a:ext>
            </a:extLst>
          </p:cNvPr>
          <p:cNvCxnSpPr/>
          <p:nvPr/>
        </p:nvCxnSpPr>
        <p:spPr>
          <a:xfrm>
            <a:off x="1105627" y="4664491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886F2916-6E4D-7A61-B0CD-8FDC84C5319B}"/>
              </a:ext>
            </a:extLst>
          </p:cNvPr>
          <p:cNvSpPr txBox="1"/>
          <p:nvPr/>
        </p:nvSpPr>
        <p:spPr>
          <a:xfrm>
            <a:off x="8854133" y="2299368"/>
            <a:ext cx="15256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7A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C50D850-9B9C-DEFB-D9A4-AA1B509B416B}"/>
              </a:ext>
            </a:extLst>
          </p:cNvPr>
          <p:cNvSpPr txBox="1"/>
          <p:nvPr/>
        </p:nvSpPr>
        <p:spPr>
          <a:xfrm>
            <a:off x="2527300" y="1124304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DCB9A92-63F4-66B7-FA9B-790309DB9081}"/>
              </a:ext>
            </a:extLst>
          </p:cNvPr>
          <p:cNvSpPr txBox="1"/>
          <p:nvPr/>
        </p:nvSpPr>
        <p:spPr>
          <a:xfrm>
            <a:off x="5419617" y="1124304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1877346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C6714D48-A53E-6B37-57AA-EF15DC9197E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8281221" y="2302112"/>
            <a:ext cx="3736000" cy="2082858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2B006FD-7826-767A-2055-004211022A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4859" y="5596141"/>
            <a:ext cx="2992042" cy="65357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B113E12-3DD8-2279-B05F-DE36386812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26440" y="5454683"/>
            <a:ext cx="3337213" cy="87592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717B9BB-E985-540A-6EF1-7B5C19382EB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04859" y="4561035"/>
            <a:ext cx="2992043" cy="69753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CC24A49-17CC-A2B0-9F11-CBE1BF6258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26440" y="4271989"/>
            <a:ext cx="3177599" cy="89816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DCC9F815-6C33-E781-A4F2-A80C6912E0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04859" y="3482678"/>
            <a:ext cx="3082589" cy="73604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9D157BC3-FD51-F5CF-BAE2-21492E4AA4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26440" y="3343541"/>
            <a:ext cx="2771648" cy="67175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09FF4747-ADF7-4F8E-7A62-3D38F8DE4B9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11045" y="2505807"/>
            <a:ext cx="3153768" cy="54354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143C77DE-3E63-2C38-3FA2-2DDE9433D95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26440" y="2390841"/>
            <a:ext cx="2862497" cy="75426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79119D65-286C-AA07-CFF6-25797D9013F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26440" y="1521722"/>
            <a:ext cx="3099855" cy="627003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CE76A8D8-63E9-EFFB-7F3A-11535DC2FA1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3769"/>
          <a:stretch/>
        </p:blipFill>
        <p:spPr>
          <a:xfrm>
            <a:off x="4964958" y="1567208"/>
            <a:ext cx="3099855" cy="573996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CD838EAD-EB9D-9638-706B-617E6B905289}"/>
              </a:ext>
            </a:extLst>
          </p:cNvPr>
          <p:cNvSpPr txBox="1"/>
          <p:nvPr/>
        </p:nvSpPr>
        <p:spPr>
          <a:xfrm>
            <a:off x="8964761" y="1687060"/>
            <a:ext cx="156053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7C</a:t>
            </a:r>
            <a:endParaRPr lang="zh-CN" altLang="en-US" sz="24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73C848F-9AE5-E0BA-5F08-A510839D3C87}"/>
              </a:ext>
            </a:extLst>
          </p:cNvPr>
          <p:cNvSpPr txBox="1"/>
          <p:nvPr/>
        </p:nvSpPr>
        <p:spPr>
          <a:xfrm>
            <a:off x="567030" y="1451451"/>
            <a:ext cx="585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4075093-3A46-ED87-8E68-700A4A993B94}"/>
              </a:ext>
            </a:extLst>
          </p:cNvPr>
          <p:cNvSpPr txBox="1"/>
          <p:nvPr/>
        </p:nvSpPr>
        <p:spPr>
          <a:xfrm>
            <a:off x="544581" y="2615907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DF6F831-3F38-D1D5-8857-E596465E15DE}"/>
              </a:ext>
            </a:extLst>
          </p:cNvPr>
          <p:cNvSpPr txBox="1"/>
          <p:nvPr/>
        </p:nvSpPr>
        <p:spPr>
          <a:xfrm>
            <a:off x="594486" y="346225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5070772-B85F-C010-F01E-148AB363B202}"/>
              </a:ext>
            </a:extLst>
          </p:cNvPr>
          <p:cNvSpPr txBox="1"/>
          <p:nvPr/>
        </p:nvSpPr>
        <p:spPr>
          <a:xfrm>
            <a:off x="630358" y="3729891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76EA0D5-6BF4-70CD-6E05-08BD195A1683}"/>
              </a:ext>
            </a:extLst>
          </p:cNvPr>
          <p:cNvSpPr txBox="1"/>
          <p:nvPr/>
        </p:nvSpPr>
        <p:spPr>
          <a:xfrm>
            <a:off x="530469" y="285873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D06D324-8BCD-DE03-5B20-CE1797DEE555}"/>
              </a:ext>
            </a:extLst>
          </p:cNvPr>
          <p:cNvSpPr txBox="1"/>
          <p:nvPr/>
        </p:nvSpPr>
        <p:spPr>
          <a:xfrm>
            <a:off x="572086" y="1668680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48ED09C-B51C-7824-61DC-139D93CE747A}"/>
              </a:ext>
            </a:extLst>
          </p:cNvPr>
          <p:cNvSpPr txBox="1"/>
          <p:nvPr/>
        </p:nvSpPr>
        <p:spPr>
          <a:xfrm>
            <a:off x="543729" y="5816081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1032BAB-3677-7B5E-2D5F-52AAD049F522}"/>
              </a:ext>
            </a:extLst>
          </p:cNvPr>
          <p:cNvSpPr txBox="1"/>
          <p:nvPr/>
        </p:nvSpPr>
        <p:spPr>
          <a:xfrm>
            <a:off x="536749" y="5673673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007062B-8E85-C868-23D2-E6ECA904071F}"/>
              </a:ext>
            </a:extLst>
          </p:cNvPr>
          <p:cNvSpPr txBox="1"/>
          <p:nvPr/>
        </p:nvSpPr>
        <p:spPr>
          <a:xfrm>
            <a:off x="549680" y="551030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3B66A63E-0379-681D-5489-E3886A62F265}"/>
              </a:ext>
            </a:extLst>
          </p:cNvPr>
          <p:cNvCxnSpPr/>
          <p:nvPr/>
        </p:nvCxnSpPr>
        <p:spPr>
          <a:xfrm>
            <a:off x="1151221" y="566419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237FE380-6331-AC21-3CA5-19410F586F49}"/>
              </a:ext>
            </a:extLst>
          </p:cNvPr>
          <p:cNvCxnSpPr/>
          <p:nvPr/>
        </p:nvCxnSpPr>
        <p:spPr>
          <a:xfrm>
            <a:off x="1138290" y="5827561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CF12BC44-DC30-8B76-8E41-A618A1F33F7C}"/>
              </a:ext>
            </a:extLst>
          </p:cNvPr>
          <p:cNvCxnSpPr/>
          <p:nvPr/>
        </p:nvCxnSpPr>
        <p:spPr>
          <a:xfrm>
            <a:off x="1138290" y="598382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2AFD414A-B92B-5916-AB38-A9D762E28CF9}"/>
              </a:ext>
            </a:extLst>
          </p:cNvPr>
          <p:cNvCxnSpPr/>
          <p:nvPr/>
        </p:nvCxnSpPr>
        <p:spPr>
          <a:xfrm>
            <a:off x="1129919" y="3634813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424EC198-B2B4-14E9-F753-1F06DB30FB32}"/>
              </a:ext>
            </a:extLst>
          </p:cNvPr>
          <p:cNvCxnSpPr/>
          <p:nvPr/>
        </p:nvCxnSpPr>
        <p:spPr>
          <a:xfrm>
            <a:off x="1129919" y="3900297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A6032BE9-7721-B452-C4E2-47F9D3D665BF}"/>
              </a:ext>
            </a:extLst>
          </p:cNvPr>
          <p:cNvCxnSpPr/>
          <p:nvPr/>
        </p:nvCxnSpPr>
        <p:spPr>
          <a:xfrm>
            <a:off x="1080014" y="277641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D1EB4EE7-BAF9-80D5-8499-2E226D296173}"/>
              </a:ext>
            </a:extLst>
          </p:cNvPr>
          <p:cNvCxnSpPr/>
          <p:nvPr/>
        </p:nvCxnSpPr>
        <p:spPr>
          <a:xfrm>
            <a:off x="1087527" y="301213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41F443C7-19DA-D9C0-3FEA-5BCB8AF476AA}"/>
              </a:ext>
            </a:extLst>
          </p:cNvPr>
          <p:cNvCxnSpPr/>
          <p:nvPr/>
        </p:nvCxnSpPr>
        <p:spPr>
          <a:xfrm>
            <a:off x="1087527" y="164984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D152B9A4-F384-B0FA-ADFE-ED82F14659D1}"/>
              </a:ext>
            </a:extLst>
          </p:cNvPr>
          <p:cNvCxnSpPr/>
          <p:nvPr/>
        </p:nvCxnSpPr>
        <p:spPr>
          <a:xfrm>
            <a:off x="1100051" y="185420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2522108D-C14A-6F4A-D4F5-74E16DC6A404}"/>
              </a:ext>
            </a:extLst>
          </p:cNvPr>
          <p:cNvSpPr txBox="1"/>
          <p:nvPr/>
        </p:nvSpPr>
        <p:spPr>
          <a:xfrm>
            <a:off x="564618" y="4889284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5kd</a:t>
            </a:r>
            <a:endParaRPr lang="zh-CN" altLang="en-US" sz="1400" b="1" dirty="0"/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42E47CD1-C259-FA41-A363-273E06503D5D}"/>
              </a:ext>
            </a:extLst>
          </p:cNvPr>
          <p:cNvCxnSpPr/>
          <p:nvPr/>
        </p:nvCxnSpPr>
        <p:spPr>
          <a:xfrm>
            <a:off x="1100051" y="504317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0632963B-8674-D7F3-DCDD-6211B49C7C7A}"/>
              </a:ext>
            </a:extLst>
          </p:cNvPr>
          <p:cNvSpPr txBox="1"/>
          <p:nvPr/>
        </p:nvSpPr>
        <p:spPr>
          <a:xfrm>
            <a:off x="2582026" y="1098567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F9892A6-AC06-81F5-F818-5F17D1E44072}"/>
              </a:ext>
            </a:extLst>
          </p:cNvPr>
          <p:cNvSpPr txBox="1"/>
          <p:nvPr/>
        </p:nvSpPr>
        <p:spPr>
          <a:xfrm>
            <a:off x="5928320" y="1098567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7375956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934C2E4-16B0-9B98-0449-23A38CF98D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71942" y="2370662"/>
            <a:ext cx="3146646" cy="21166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D3AF1F4-6BB4-495C-FA93-0A89B9BC36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0521" y="5892233"/>
            <a:ext cx="3370910" cy="71295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AADC8AC-0AA0-4E3E-6F67-6EDD160358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81441" y="2654948"/>
            <a:ext cx="3370911" cy="87394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2974B5B-CAA8-4887-FC5E-18CE17146CD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8250"/>
          <a:stretch/>
        </p:blipFill>
        <p:spPr>
          <a:xfrm>
            <a:off x="1496417" y="2564057"/>
            <a:ext cx="3144855" cy="98892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9E9AA23D-FBD5-3E19-BCB7-70C2CDAAFCF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88095" y="5903885"/>
            <a:ext cx="3047874" cy="763426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1C8400A2-009A-DD6B-4414-D0BE02C1B49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88095" y="4798218"/>
            <a:ext cx="3047874" cy="900816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7F843637-0544-BE59-4D3E-3CDEEBF072E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5813" y="4782775"/>
            <a:ext cx="3370911" cy="90783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0E2477D-E6B6-DC0B-1AEA-BC38AC1ABDA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81442" y="3766082"/>
            <a:ext cx="3193389" cy="81507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F2C76F6-AE37-A302-206D-799F7499086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992155" y="608275"/>
            <a:ext cx="3321496" cy="966383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A441004A-6A43-3547-0D9B-1D8DD26E743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5172"/>
          <a:stretch/>
        </p:blipFill>
        <p:spPr>
          <a:xfrm>
            <a:off x="4992155" y="1704122"/>
            <a:ext cx="3370910" cy="82136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817ACF75-F570-38C5-622C-41AD65B64C8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44907" y="930682"/>
            <a:ext cx="3047874" cy="388142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0E0CFFCA-EDE8-E3A1-DDDF-C00D1912F61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87719" y="1767172"/>
            <a:ext cx="3195559" cy="622086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A3EFDBE3-1477-B4A2-F33F-4DE0F7FFCEB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544907" y="3623947"/>
            <a:ext cx="3047874" cy="1071846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6CC79DDF-B62B-70CE-6CBF-2D9DFB1060FA}"/>
              </a:ext>
            </a:extLst>
          </p:cNvPr>
          <p:cNvSpPr txBox="1"/>
          <p:nvPr/>
        </p:nvSpPr>
        <p:spPr>
          <a:xfrm>
            <a:off x="8949733" y="1530166"/>
            <a:ext cx="157941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Figure7F</a:t>
            </a:r>
            <a:endParaRPr lang="en-US" altLang="zh-CN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B91489B-8A75-C617-1CCF-1F792FEC9540}"/>
              </a:ext>
            </a:extLst>
          </p:cNvPr>
          <p:cNvSpPr txBox="1"/>
          <p:nvPr/>
        </p:nvSpPr>
        <p:spPr>
          <a:xfrm>
            <a:off x="509693" y="776793"/>
            <a:ext cx="585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F6FBC5F-1CE3-79EE-2A60-D7EE449D8BF7}"/>
              </a:ext>
            </a:extLst>
          </p:cNvPr>
          <p:cNvSpPr txBox="1"/>
          <p:nvPr/>
        </p:nvSpPr>
        <p:spPr>
          <a:xfrm>
            <a:off x="483179" y="1849039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70kd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3DB3620-F243-8FC0-409C-E7FC4A8CC64B}"/>
              </a:ext>
            </a:extLst>
          </p:cNvPr>
          <p:cNvSpPr txBox="1"/>
          <p:nvPr/>
        </p:nvSpPr>
        <p:spPr>
          <a:xfrm>
            <a:off x="537149" y="2787596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40kd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DB75705-ED18-F894-05E0-4377E4848F8F}"/>
              </a:ext>
            </a:extLst>
          </p:cNvPr>
          <p:cNvSpPr txBox="1"/>
          <p:nvPr/>
        </p:nvSpPr>
        <p:spPr>
          <a:xfrm>
            <a:off x="569035" y="3296603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35kd</a:t>
            </a:r>
            <a:endParaRPr lang="zh-CN" altLang="en-US" sz="14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8024F69-DB24-2EE1-0676-8202FEC62B9B}"/>
              </a:ext>
            </a:extLst>
          </p:cNvPr>
          <p:cNvSpPr txBox="1"/>
          <p:nvPr/>
        </p:nvSpPr>
        <p:spPr>
          <a:xfrm>
            <a:off x="469067" y="2091866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6E6800B-3335-D082-BC2C-B8D707A14367}"/>
              </a:ext>
            </a:extLst>
          </p:cNvPr>
          <p:cNvSpPr txBox="1"/>
          <p:nvPr/>
        </p:nvSpPr>
        <p:spPr>
          <a:xfrm>
            <a:off x="514749" y="994022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55kd</a:t>
            </a:r>
            <a:endParaRPr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9E238E6-3C13-90DC-54E1-97A23F9DC599}"/>
              </a:ext>
            </a:extLst>
          </p:cNvPr>
          <p:cNvSpPr txBox="1"/>
          <p:nvPr/>
        </p:nvSpPr>
        <p:spPr>
          <a:xfrm>
            <a:off x="499323" y="530218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B502071-614D-068D-2CA9-D3AAF35CA70D}"/>
              </a:ext>
            </a:extLst>
          </p:cNvPr>
          <p:cNvSpPr txBox="1"/>
          <p:nvPr/>
        </p:nvSpPr>
        <p:spPr>
          <a:xfrm>
            <a:off x="479412" y="4999015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3D0036D-D90A-1C30-1DDC-B1C6A7422279}"/>
              </a:ext>
            </a:extLst>
          </p:cNvPr>
          <p:cNvSpPr txBox="1"/>
          <p:nvPr/>
        </p:nvSpPr>
        <p:spPr>
          <a:xfrm>
            <a:off x="492343" y="4835644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FC919704-8FFF-486D-B4B9-4385A35A0A6F}"/>
              </a:ext>
            </a:extLst>
          </p:cNvPr>
          <p:cNvCxnSpPr/>
          <p:nvPr/>
        </p:nvCxnSpPr>
        <p:spPr>
          <a:xfrm>
            <a:off x="1093884" y="498953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44D76E08-8F8F-B26B-D350-0209CB1963E7}"/>
              </a:ext>
            </a:extLst>
          </p:cNvPr>
          <p:cNvCxnSpPr/>
          <p:nvPr/>
        </p:nvCxnSpPr>
        <p:spPr>
          <a:xfrm>
            <a:off x="1080953" y="5152903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8871AC34-C349-0043-21B1-78F17995F14C}"/>
              </a:ext>
            </a:extLst>
          </p:cNvPr>
          <p:cNvCxnSpPr/>
          <p:nvPr/>
        </p:nvCxnSpPr>
        <p:spPr>
          <a:xfrm>
            <a:off x="1093884" y="546992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278509BE-F370-9AAD-46A4-23DE4F04765D}"/>
              </a:ext>
            </a:extLst>
          </p:cNvPr>
          <p:cNvCxnSpPr/>
          <p:nvPr/>
        </p:nvCxnSpPr>
        <p:spPr>
          <a:xfrm>
            <a:off x="1072582" y="296015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8429FBE6-212A-7A05-7A8D-ECA376FA733F}"/>
              </a:ext>
            </a:extLst>
          </p:cNvPr>
          <p:cNvCxnSpPr/>
          <p:nvPr/>
        </p:nvCxnSpPr>
        <p:spPr>
          <a:xfrm>
            <a:off x="1068596" y="3467009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CCFE0CE2-9526-D066-ABBE-6A0F2AAA0245}"/>
              </a:ext>
            </a:extLst>
          </p:cNvPr>
          <p:cNvCxnSpPr/>
          <p:nvPr/>
        </p:nvCxnSpPr>
        <p:spPr>
          <a:xfrm>
            <a:off x="1018612" y="2009542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22C34277-B270-2DA2-1DB1-A2319DB57F55}"/>
              </a:ext>
            </a:extLst>
          </p:cNvPr>
          <p:cNvCxnSpPr/>
          <p:nvPr/>
        </p:nvCxnSpPr>
        <p:spPr>
          <a:xfrm>
            <a:off x="1026125" y="224526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BCC200E2-E583-C1BE-EAE6-3C36373A8B94}"/>
              </a:ext>
            </a:extLst>
          </p:cNvPr>
          <p:cNvCxnSpPr/>
          <p:nvPr/>
        </p:nvCxnSpPr>
        <p:spPr>
          <a:xfrm>
            <a:off x="1030190" y="975184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31EC964D-2F78-DAA4-B2F6-5B09BC737686}"/>
              </a:ext>
            </a:extLst>
          </p:cNvPr>
          <p:cNvCxnSpPr/>
          <p:nvPr/>
        </p:nvCxnSpPr>
        <p:spPr>
          <a:xfrm>
            <a:off x="1042714" y="117954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C679A8E0-02A7-0CA9-C85A-45F892F6B0E8}"/>
              </a:ext>
            </a:extLst>
          </p:cNvPr>
          <p:cNvSpPr txBox="1"/>
          <p:nvPr/>
        </p:nvSpPr>
        <p:spPr>
          <a:xfrm>
            <a:off x="587133" y="3608582"/>
            <a:ext cx="585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25kd</a:t>
            </a:r>
            <a:endParaRPr lang="zh-CN" altLang="en-US" sz="1400" b="1" dirty="0"/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3BAFCDE6-71B1-7FEA-E8A6-9579B3D6D2D0}"/>
              </a:ext>
            </a:extLst>
          </p:cNvPr>
          <p:cNvCxnSpPr/>
          <p:nvPr/>
        </p:nvCxnSpPr>
        <p:spPr>
          <a:xfrm>
            <a:off x="1122566" y="3762470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C5284DC0-1ABA-3AEC-73B7-E4FD9562DBD8}"/>
              </a:ext>
            </a:extLst>
          </p:cNvPr>
          <p:cNvSpPr txBox="1"/>
          <p:nvPr/>
        </p:nvSpPr>
        <p:spPr>
          <a:xfrm>
            <a:off x="557060" y="6296425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00kd</a:t>
            </a:r>
            <a:endParaRPr lang="zh-CN" altLang="en-US" sz="1400" b="1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73C1C5C-91D7-074A-0540-E9C4ABCA041C}"/>
              </a:ext>
            </a:extLst>
          </p:cNvPr>
          <p:cNvSpPr txBox="1"/>
          <p:nvPr/>
        </p:nvSpPr>
        <p:spPr>
          <a:xfrm>
            <a:off x="537149" y="599325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30kd</a:t>
            </a:r>
            <a:endParaRPr lang="zh-CN" altLang="en-US" sz="1400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C07798-AAF0-8397-3961-A76C21AAEDFF}"/>
              </a:ext>
            </a:extLst>
          </p:cNvPr>
          <p:cNvSpPr txBox="1"/>
          <p:nvPr/>
        </p:nvSpPr>
        <p:spPr>
          <a:xfrm>
            <a:off x="550080" y="5829887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170kd</a:t>
            </a:r>
            <a:endParaRPr lang="zh-CN" altLang="en-US" sz="1400" b="1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5BAF4799-F17C-F679-CE3F-6922C6B53433}"/>
              </a:ext>
            </a:extLst>
          </p:cNvPr>
          <p:cNvCxnSpPr/>
          <p:nvPr/>
        </p:nvCxnSpPr>
        <p:spPr>
          <a:xfrm>
            <a:off x="1151621" y="5983775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B7C508ED-419F-642B-8E56-2539B2224567}"/>
              </a:ext>
            </a:extLst>
          </p:cNvPr>
          <p:cNvCxnSpPr/>
          <p:nvPr/>
        </p:nvCxnSpPr>
        <p:spPr>
          <a:xfrm>
            <a:off x="1138690" y="6147146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13C22C20-6BB5-9351-2DCE-A4050D24643E}"/>
              </a:ext>
            </a:extLst>
          </p:cNvPr>
          <p:cNvCxnSpPr/>
          <p:nvPr/>
        </p:nvCxnSpPr>
        <p:spPr>
          <a:xfrm>
            <a:off x="1151621" y="6464168"/>
            <a:ext cx="64423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CE11399B-1302-9396-111E-101AD02A5C6A}"/>
              </a:ext>
            </a:extLst>
          </p:cNvPr>
          <p:cNvSpPr txBox="1"/>
          <p:nvPr/>
        </p:nvSpPr>
        <p:spPr>
          <a:xfrm>
            <a:off x="2536778" y="238943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MKN45</a:t>
            </a:r>
            <a:endParaRPr lang="zh-CN" altLang="en-US" b="1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F996772E-537F-B4C9-36FB-B794206E851C}"/>
              </a:ext>
            </a:extLst>
          </p:cNvPr>
          <p:cNvSpPr txBox="1"/>
          <p:nvPr/>
        </p:nvSpPr>
        <p:spPr>
          <a:xfrm>
            <a:off x="6226982" y="238943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CI-N8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25900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6</TotalTime>
  <Words>118</Words>
  <Application>Microsoft Office PowerPoint</Application>
  <PresentationFormat>宽屏</PresentationFormat>
  <Paragraphs>118</Paragraphs>
  <Slides>8</Slides>
  <Notes>8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 珍珍</dc:creator>
  <cp:lastModifiedBy>Gang</cp:lastModifiedBy>
  <cp:revision>25</cp:revision>
  <dcterms:created xsi:type="dcterms:W3CDTF">2022-07-11T14:32:24Z</dcterms:created>
  <dcterms:modified xsi:type="dcterms:W3CDTF">2022-07-12T09:22:33Z</dcterms:modified>
</cp:coreProperties>
</file>